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79F649-B612-4FA2-B65D-3BA7161F764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85E302-E5E8-421F-B63A-5FC75B7C4C2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832B16-2F0E-48AB-91F7-A30CF0385AE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E27A5E-38F0-401A-A8B4-0A37895725A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977969-A386-4FAB-AFD4-C8D3798268E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9F6A2E-1C3C-412E-887E-D45BF8ED964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B5D000-81B9-41A2-8490-72199A75A97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5EF7D6-F2CC-42D8-97E1-AD006278F6B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BBDB6F-2396-4B56-B797-EC7248A98F3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EC10C1-CE48-4E40-A73A-CC0C03404B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61F34E-24FD-418C-A1B3-D05D57A517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6446DF-32DE-4572-8C14-30BFE41154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52CD453-FC88-4245-9B0D-430971F7DDED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5"/>
          <p:cNvSpPr/>
          <p:nvPr/>
        </p:nvSpPr>
        <p:spPr>
          <a:xfrm>
            <a:off x="0" y="0"/>
            <a:ext cx="6786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Times New Roman"/>
              </a:rPr>
              <a:t>Figure S1: </a:t>
            </a: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Reference 2D electrophoresis gel map for exponential Deinococcus deserti VCD115 cell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Object 97"/>
          <p:cNvGraphicFramePr/>
          <p:nvPr/>
        </p:nvGraphicFramePr>
        <p:xfrm>
          <a:off x="333360" y="1187280"/>
          <a:ext cx="6350040" cy="68407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3" name="Object 97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33360" y="1187280"/>
                    <a:ext cx="6350040" cy="6840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4" name="ZoneTexte 1"/>
          <p:cNvSpPr/>
          <p:nvPr/>
        </p:nvSpPr>
        <p:spPr>
          <a:xfrm>
            <a:off x="3209760" y="826920"/>
            <a:ext cx="432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ZoneTexte 2"/>
          <p:cNvSpPr/>
          <p:nvPr/>
        </p:nvSpPr>
        <p:spPr>
          <a:xfrm>
            <a:off x="333360" y="826920"/>
            <a:ext cx="358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ZoneTexte 3"/>
          <p:cNvSpPr/>
          <p:nvPr/>
        </p:nvSpPr>
        <p:spPr>
          <a:xfrm>
            <a:off x="6093000" y="817560"/>
            <a:ext cx="693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ZoneTexte 4"/>
          <p:cNvSpPr/>
          <p:nvPr/>
        </p:nvSpPr>
        <p:spPr>
          <a:xfrm>
            <a:off x="-55440" y="3957480"/>
            <a:ext cx="6206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W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ZoneTexte 5"/>
          <p:cNvSpPr/>
          <p:nvPr/>
        </p:nvSpPr>
        <p:spPr>
          <a:xfrm>
            <a:off x="0" y="7586640"/>
            <a:ext cx="498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ZoneTexte 6"/>
          <p:cNvSpPr/>
          <p:nvPr/>
        </p:nvSpPr>
        <p:spPr>
          <a:xfrm>
            <a:off x="0" y="4932360"/>
            <a:ext cx="404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ZoneTexte 7"/>
          <p:cNvSpPr/>
          <p:nvPr/>
        </p:nvSpPr>
        <p:spPr>
          <a:xfrm>
            <a:off x="-55440" y="1616040"/>
            <a:ext cx="693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6.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29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11T15:19:46Z</dcterms:created>
  <dc:creator>Alain DEDIEU</dc:creator>
  <dc:description/>
  <dc:language>en-US</dc:language>
  <cp:lastModifiedBy>DEDIEU Alain</cp:lastModifiedBy>
  <dcterms:modified xsi:type="dcterms:W3CDTF">2012-07-26T09:23:28Z</dcterms:modified>
  <cp:revision>22</cp:revision>
  <dc:subject/>
  <dc:title>Diapositive 1</dc:title>
</cp:coreProperties>
</file>